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EE6D"/>
    <a:srgbClr val="538FFA"/>
    <a:srgbClr val="0090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706"/>
    <p:restoredTop sz="94644"/>
  </p:normalViewPr>
  <p:slideViewPr>
    <p:cSldViewPr snapToGrid="0" snapToObjects="1">
      <p:cViewPr varScale="1">
        <p:scale>
          <a:sx n="56" d="100"/>
          <a:sy n="56" d="100"/>
        </p:scale>
        <p:origin x="345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F5EDC-D618-C143-B598-C7A80BF1A6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604D2-9A80-0646-BD00-C7EAED262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916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F5EDC-D618-C143-B598-C7A80BF1A6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604D2-9A80-0646-BD00-C7EAED262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690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F5EDC-D618-C143-B598-C7A80BF1A6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604D2-9A80-0646-BD00-C7EAED262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231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F5EDC-D618-C143-B598-C7A80BF1A6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604D2-9A80-0646-BD00-C7EAED262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991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F5EDC-D618-C143-B598-C7A80BF1A6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604D2-9A80-0646-BD00-C7EAED262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122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F5EDC-D618-C143-B598-C7A80BF1A6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604D2-9A80-0646-BD00-C7EAED262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745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F5EDC-D618-C143-B598-C7A80BF1A6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604D2-9A80-0646-BD00-C7EAED262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584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F5EDC-D618-C143-B598-C7A80BF1A6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604D2-9A80-0646-BD00-C7EAED262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40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F5EDC-D618-C143-B598-C7A80BF1A6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604D2-9A80-0646-BD00-C7EAED262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989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F5EDC-D618-C143-B598-C7A80BF1A6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604D2-9A80-0646-BD00-C7EAED262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60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F5EDC-D618-C143-B598-C7A80BF1A6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604D2-9A80-0646-BD00-C7EAED262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451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AF5EDC-D618-C143-B598-C7A80BF1A6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8604D2-9A80-0646-BD00-C7EAED262E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406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A847D1EE-06BE-5C49-AC40-BB5E15C0EC01}"/>
              </a:ext>
            </a:extLst>
          </p:cNvPr>
          <p:cNvGrpSpPr/>
          <p:nvPr/>
        </p:nvGrpSpPr>
        <p:grpSpPr>
          <a:xfrm>
            <a:off x="79124" y="608452"/>
            <a:ext cx="6094620" cy="8307144"/>
            <a:chOff x="203993" y="3143308"/>
            <a:chExt cx="6094620" cy="8307144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C4ADD00-1C73-9046-AC6A-E6E987DB77C8}"/>
                </a:ext>
              </a:extLst>
            </p:cNvPr>
            <p:cNvSpPr txBox="1"/>
            <p:nvPr/>
          </p:nvSpPr>
          <p:spPr>
            <a:xfrm>
              <a:off x="250129" y="3143308"/>
              <a:ext cx="1847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04F4846-D5D3-424D-9682-2B20EB809C04}"/>
                </a:ext>
              </a:extLst>
            </p:cNvPr>
            <p:cNvSpPr txBox="1"/>
            <p:nvPr/>
          </p:nvSpPr>
          <p:spPr>
            <a:xfrm rot="16200000">
              <a:off x="-350966" y="6740701"/>
              <a:ext cx="13869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Gene expression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B96136EE-9233-7443-A942-39A3E4E9A6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6784"/>
            <a:stretch/>
          </p:blipFill>
          <p:spPr>
            <a:xfrm>
              <a:off x="613117" y="3297196"/>
              <a:ext cx="5685496" cy="6934933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0B7A138-F2D4-124C-9AB8-C36DB0818F70}"/>
                </a:ext>
              </a:extLst>
            </p:cNvPr>
            <p:cNvSpPr txBox="1"/>
            <p:nvPr/>
          </p:nvSpPr>
          <p:spPr>
            <a:xfrm rot="16200000">
              <a:off x="822366" y="10371085"/>
              <a:ext cx="5469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RF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21B3614-47DA-6A4F-9878-59D58C847507}"/>
                </a:ext>
              </a:extLst>
            </p:cNvPr>
            <p:cNvSpPr txBox="1"/>
            <p:nvPr/>
          </p:nvSpPr>
          <p:spPr>
            <a:xfrm rot="16200000">
              <a:off x="1038683" y="10429004"/>
              <a:ext cx="66556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DCD1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985D6E4-F7D1-0742-9AF2-8D1A8B8ECC1A}"/>
                </a:ext>
              </a:extLst>
            </p:cNvPr>
            <p:cNvSpPr txBox="1"/>
            <p:nvPr/>
          </p:nvSpPr>
          <p:spPr>
            <a:xfrm rot="16200000">
              <a:off x="1328187" y="10408734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GFB1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7A63D5F-AF8F-CF4F-A5A2-08C32A005569}"/>
                </a:ext>
              </a:extLst>
            </p:cNvPr>
            <p:cNvSpPr txBox="1"/>
            <p:nvPr/>
          </p:nvSpPr>
          <p:spPr>
            <a:xfrm rot="16200000">
              <a:off x="1537106" y="10492819"/>
              <a:ext cx="7681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HAVCR2</a:t>
              </a:r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FA5CDDF4-E797-8747-A99C-B99308F66DF9}"/>
                </a:ext>
              </a:extLst>
            </p:cNvPr>
            <p:cNvGrpSpPr/>
            <p:nvPr/>
          </p:nvGrpSpPr>
          <p:grpSpPr>
            <a:xfrm>
              <a:off x="1016147" y="10200379"/>
              <a:ext cx="148897" cy="102496"/>
              <a:chOff x="1016147" y="10200379"/>
              <a:chExt cx="148897" cy="102496"/>
            </a:xfrm>
          </p:grpSpPr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7CA12FAC-A6D1-314F-B74E-9681F2C3246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F9EAA7A5-4C5B-504D-B1D9-941812067BE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1923E06B-C9E3-EB41-87B5-0DE1E76B2473}"/>
                </a:ext>
              </a:extLst>
            </p:cNvPr>
            <p:cNvGrpSpPr/>
            <p:nvPr/>
          </p:nvGrpSpPr>
          <p:grpSpPr>
            <a:xfrm>
              <a:off x="1290667" y="10203554"/>
              <a:ext cx="148897" cy="102496"/>
              <a:chOff x="1016147" y="10200379"/>
              <a:chExt cx="148897" cy="102496"/>
            </a:xfrm>
          </p:grpSpPr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50DB556D-F5C0-8247-A89D-79BFDEA009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EAC8CF2C-2C94-604D-91B4-53568764C26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3DA02774-27DC-194A-B6CD-E6B1352EB299}"/>
                </a:ext>
              </a:extLst>
            </p:cNvPr>
            <p:cNvGrpSpPr/>
            <p:nvPr/>
          </p:nvGrpSpPr>
          <p:grpSpPr>
            <a:xfrm>
              <a:off x="1568362" y="10203554"/>
              <a:ext cx="148897" cy="102496"/>
              <a:chOff x="1016147" y="10200379"/>
              <a:chExt cx="148897" cy="102496"/>
            </a:xfrm>
          </p:grpSpPr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BDEF4321-CD17-394C-81BD-4DC72B83842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4A3562B9-E51C-0D4B-B884-97B7C3482F5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8C37B830-0764-224A-88C7-181296056704}"/>
                </a:ext>
              </a:extLst>
            </p:cNvPr>
            <p:cNvGrpSpPr/>
            <p:nvPr/>
          </p:nvGrpSpPr>
          <p:grpSpPr>
            <a:xfrm>
              <a:off x="1846057" y="10200379"/>
              <a:ext cx="148897" cy="102496"/>
              <a:chOff x="1016147" y="10200379"/>
              <a:chExt cx="148897" cy="102496"/>
            </a:xfrm>
          </p:grpSpPr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CFF5317F-89C4-5D47-BEC8-209D33D5A5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id="{B0CCDA84-96AB-6A47-A0DA-E2EB4C3F66D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DB1F0627-E639-BF49-B67C-D71B88A810B0}"/>
                </a:ext>
              </a:extLst>
            </p:cNvPr>
            <p:cNvGrpSpPr/>
            <p:nvPr/>
          </p:nvGrpSpPr>
          <p:grpSpPr>
            <a:xfrm>
              <a:off x="2117402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2411929C-C527-9E49-B995-CF53F7975D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442D18D1-CE06-1944-864A-E633542B2A5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4312D24F-8A96-AB41-910D-01E8E314D765}"/>
                </a:ext>
              </a:extLst>
            </p:cNvPr>
            <p:cNvGrpSpPr/>
            <p:nvPr/>
          </p:nvGrpSpPr>
          <p:grpSpPr>
            <a:xfrm>
              <a:off x="2391922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5C9824E3-47B7-2544-8F50-14407552DD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D5B864C4-6EE7-4845-A88C-9A483C07292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DCFF1A86-07EE-BB45-9661-693DC34D7804}"/>
                </a:ext>
              </a:extLst>
            </p:cNvPr>
            <p:cNvGrpSpPr/>
            <p:nvPr/>
          </p:nvGrpSpPr>
          <p:grpSpPr>
            <a:xfrm>
              <a:off x="2666442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id="{60464F3E-8D43-544A-91B9-63F368CA18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C75A8B55-497C-7A42-90A7-35EEC8F8807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F9D51A9C-D169-F446-8590-94795B708412}"/>
                </a:ext>
              </a:extLst>
            </p:cNvPr>
            <p:cNvGrpSpPr/>
            <p:nvPr/>
          </p:nvGrpSpPr>
          <p:grpSpPr>
            <a:xfrm>
              <a:off x="2940962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id="{0DA64893-B401-9540-9508-A82E4AFD5C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920FD956-69D2-AE43-BDCB-EBE458F7629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9A39AF82-4A8E-4747-BCA8-204769144E43}"/>
                </a:ext>
              </a:extLst>
            </p:cNvPr>
            <p:cNvGrpSpPr/>
            <p:nvPr/>
          </p:nvGrpSpPr>
          <p:grpSpPr>
            <a:xfrm>
              <a:off x="3215482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924EFC03-ABEB-2342-BB6E-9CCB112C54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id="{35EAC552-E033-8244-8194-417758E2FF3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8CCB463F-28E9-3544-B1F9-707CB3E0B88D}"/>
                </a:ext>
              </a:extLst>
            </p:cNvPr>
            <p:cNvGrpSpPr/>
            <p:nvPr/>
          </p:nvGrpSpPr>
          <p:grpSpPr>
            <a:xfrm>
              <a:off x="3490002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id="{C82A67F1-4DC1-E748-A6C3-CC9E7301D6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21E54101-CE16-6846-9EE1-EFDE3FD3AD8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79A56066-CB5C-7347-8C7B-24473E54B594}"/>
                </a:ext>
              </a:extLst>
            </p:cNvPr>
            <p:cNvGrpSpPr/>
            <p:nvPr/>
          </p:nvGrpSpPr>
          <p:grpSpPr>
            <a:xfrm>
              <a:off x="3764522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id="{70FA9E75-5865-AC4E-8A59-BAFA705FCEB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id="{35BF8EB3-186E-A44D-AFBC-81756F22108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3726848D-3D68-B441-B305-50F834E65A27}"/>
                </a:ext>
              </a:extLst>
            </p:cNvPr>
            <p:cNvGrpSpPr/>
            <p:nvPr/>
          </p:nvGrpSpPr>
          <p:grpSpPr>
            <a:xfrm>
              <a:off x="4039042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66" name="Straight Connector 65">
                <a:extLst>
                  <a:ext uri="{FF2B5EF4-FFF2-40B4-BE49-F238E27FC236}">
                    <a16:creationId xmlns:a16="http://schemas.microsoft.com/office/drawing/2014/main" id="{553D781C-7359-D64D-B5B2-090DC84423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id="{8E74276E-8E92-C845-A136-B9D204DB002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7BAA3019-EA85-AB42-A9FE-F37DC5FAD34E}"/>
                </a:ext>
              </a:extLst>
            </p:cNvPr>
            <p:cNvGrpSpPr/>
            <p:nvPr/>
          </p:nvGrpSpPr>
          <p:grpSpPr>
            <a:xfrm>
              <a:off x="4313562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95763E70-0EFB-EB4D-AF9E-A63AD6AD593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ACB551C4-FDD6-224A-9635-0009E1EAC1B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id="{E1296CDD-2F3D-024D-8353-7283EACD0A37}"/>
                </a:ext>
              </a:extLst>
            </p:cNvPr>
            <p:cNvGrpSpPr/>
            <p:nvPr/>
          </p:nvGrpSpPr>
          <p:grpSpPr>
            <a:xfrm>
              <a:off x="4588082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C313A5EE-FAB3-A74A-92DF-7986367D4E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>
                <a:extLst>
                  <a:ext uri="{FF2B5EF4-FFF2-40B4-BE49-F238E27FC236}">
                    <a16:creationId xmlns:a16="http://schemas.microsoft.com/office/drawing/2014/main" id="{8AB00D75-1FF6-EC44-A2BB-BEE2254F96B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16BA312C-267B-FF44-99E9-4346BCC2B927}"/>
                </a:ext>
              </a:extLst>
            </p:cNvPr>
            <p:cNvGrpSpPr/>
            <p:nvPr/>
          </p:nvGrpSpPr>
          <p:grpSpPr>
            <a:xfrm>
              <a:off x="4862602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75" name="Straight Connector 74">
                <a:extLst>
                  <a:ext uri="{FF2B5EF4-FFF2-40B4-BE49-F238E27FC236}">
                    <a16:creationId xmlns:a16="http://schemas.microsoft.com/office/drawing/2014/main" id="{540C4881-B20F-CD47-A6F9-D256E2A6389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>
                <a:extLst>
                  <a:ext uri="{FF2B5EF4-FFF2-40B4-BE49-F238E27FC236}">
                    <a16:creationId xmlns:a16="http://schemas.microsoft.com/office/drawing/2014/main" id="{D59FAAC1-6E54-214A-94CE-9B4100065F4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048DAEB7-3D20-E742-9474-31EA525DD23B}"/>
                </a:ext>
              </a:extLst>
            </p:cNvPr>
            <p:cNvGrpSpPr/>
            <p:nvPr/>
          </p:nvGrpSpPr>
          <p:grpSpPr>
            <a:xfrm>
              <a:off x="5137122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78" name="Straight Connector 77">
                <a:extLst>
                  <a:ext uri="{FF2B5EF4-FFF2-40B4-BE49-F238E27FC236}">
                    <a16:creationId xmlns:a16="http://schemas.microsoft.com/office/drawing/2014/main" id="{F5AC225A-2841-9746-9865-E82EB1A7670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id="{3187FF50-F800-C141-98B7-9D6FA9F76E2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54E1E77F-E0E7-C240-ABA7-1E390D5A068A}"/>
                </a:ext>
              </a:extLst>
            </p:cNvPr>
            <p:cNvGrpSpPr/>
            <p:nvPr/>
          </p:nvGrpSpPr>
          <p:grpSpPr>
            <a:xfrm>
              <a:off x="5414817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F506A658-FA95-FA42-81F5-80FF3D57F3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id="{817B7FCD-D942-EB4A-8A46-B628F178CC8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A704D1C9-2AA2-974F-86E8-05E848A31F5F}"/>
                </a:ext>
              </a:extLst>
            </p:cNvPr>
            <p:cNvGrpSpPr/>
            <p:nvPr/>
          </p:nvGrpSpPr>
          <p:grpSpPr>
            <a:xfrm>
              <a:off x="5689337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84" name="Straight Connector 83">
                <a:extLst>
                  <a:ext uri="{FF2B5EF4-FFF2-40B4-BE49-F238E27FC236}">
                    <a16:creationId xmlns:a16="http://schemas.microsoft.com/office/drawing/2014/main" id="{35CFEB83-0E8A-8444-9160-CDD880D707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>
                <a:extLst>
                  <a:ext uri="{FF2B5EF4-FFF2-40B4-BE49-F238E27FC236}">
                    <a16:creationId xmlns:a16="http://schemas.microsoft.com/office/drawing/2014/main" id="{C9AC18B2-B599-AF4F-A8BA-6B1054B41BF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4355B84A-C379-C544-8ECA-F476EF752213}"/>
                </a:ext>
              </a:extLst>
            </p:cNvPr>
            <p:cNvGrpSpPr/>
            <p:nvPr/>
          </p:nvGrpSpPr>
          <p:grpSpPr>
            <a:xfrm>
              <a:off x="5963857" y="10197204"/>
              <a:ext cx="148897" cy="102496"/>
              <a:chOff x="1016147" y="10200379"/>
              <a:chExt cx="148897" cy="102496"/>
            </a:xfrm>
          </p:grpSpPr>
          <p:cxnSp>
            <p:nvCxnSpPr>
              <p:cNvPr id="87" name="Straight Connector 86">
                <a:extLst>
                  <a:ext uri="{FF2B5EF4-FFF2-40B4-BE49-F238E27FC236}">
                    <a16:creationId xmlns:a16="http://schemas.microsoft.com/office/drawing/2014/main" id="{5030BD41-3F05-834C-93E4-B2CB9EB769C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6147" y="10200379"/>
                <a:ext cx="148897" cy="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>
                <a:extLst>
                  <a:ext uri="{FF2B5EF4-FFF2-40B4-BE49-F238E27FC236}">
                    <a16:creationId xmlns:a16="http://schemas.microsoft.com/office/drawing/2014/main" id="{A9F8F539-A4F7-D94E-952F-872AC41DCD1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90595" y="10200379"/>
                <a:ext cx="0" cy="102496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60B6CEC6-D745-7947-B416-FE958D55DCA6}"/>
                </a:ext>
              </a:extLst>
            </p:cNvPr>
            <p:cNvSpPr txBox="1"/>
            <p:nvPr/>
          </p:nvSpPr>
          <p:spPr>
            <a:xfrm rot="16200000">
              <a:off x="1826582" y="10468804"/>
              <a:ext cx="74251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GALS9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B245AD72-BE65-B344-A86E-EB16155D3545}"/>
                </a:ext>
              </a:extLst>
            </p:cNvPr>
            <p:cNvSpPr txBox="1"/>
            <p:nvPr/>
          </p:nvSpPr>
          <p:spPr>
            <a:xfrm rot="16200000">
              <a:off x="2191558" y="10392854"/>
              <a:ext cx="5389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TLA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6558D4F2-D4A9-6148-9D07-3A4A1A333022}"/>
                </a:ext>
              </a:extLst>
            </p:cNvPr>
            <p:cNvSpPr txBox="1"/>
            <p:nvPr/>
          </p:nvSpPr>
          <p:spPr>
            <a:xfrm rot="16200000">
              <a:off x="2493024" y="10371084"/>
              <a:ext cx="51488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VSIR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B9F1F3B2-E28A-954F-8418-6EC1DC882BF6}"/>
                </a:ext>
              </a:extLst>
            </p:cNvPr>
            <p:cNvSpPr txBox="1"/>
            <p:nvPr/>
          </p:nvSpPr>
          <p:spPr>
            <a:xfrm rot="16200000">
              <a:off x="2689376" y="10442553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GFB2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24CC94AA-DF38-7246-AE1E-DB30D88624D7}"/>
                </a:ext>
              </a:extLst>
            </p:cNvPr>
            <p:cNvSpPr txBox="1"/>
            <p:nvPr/>
          </p:nvSpPr>
          <p:spPr>
            <a:xfrm rot="16200000">
              <a:off x="2976124" y="10437821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GFB3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56A59274-8E12-9246-92C9-2AE2D1D5B447}"/>
                </a:ext>
              </a:extLst>
            </p:cNvPr>
            <p:cNvSpPr txBox="1"/>
            <p:nvPr/>
          </p:nvSpPr>
          <p:spPr>
            <a:xfrm rot="16200000">
              <a:off x="3333293" y="10353764"/>
              <a:ext cx="4667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IL10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22EDE69-1520-7F40-9396-15814223037E}"/>
                </a:ext>
              </a:extLst>
            </p:cNvPr>
            <p:cNvSpPr txBox="1"/>
            <p:nvPr/>
          </p:nvSpPr>
          <p:spPr>
            <a:xfrm rot="16200000">
              <a:off x="3647974" y="10584273"/>
              <a:ext cx="93166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DCD1LG2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297EA547-8AD7-4042-BBFB-4A78A42EB9D1}"/>
                </a:ext>
              </a:extLst>
            </p:cNvPr>
            <p:cNvSpPr txBox="1"/>
            <p:nvPr/>
          </p:nvSpPr>
          <p:spPr>
            <a:xfrm rot="16200000">
              <a:off x="4078336" y="10423488"/>
              <a:ext cx="6254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274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2A13B0A2-C2D1-9443-BA48-43479938F1F3}"/>
                </a:ext>
              </a:extLst>
            </p:cNvPr>
            <p:cNvSpPr txBox="1"/>
            <p:nvPr/>
          </p:nvSpPr>
          <p:spPr>
            <a:xfrm rot="16200000">
              <a:off x="4345336" y="10432706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FOXP3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F94B8284-7D55-5A46-AA92-ECAF130BBAA8}"/>
                </a:ext>
              </a:extLst>
            </p:cNvPr>
            <p:cNvSpPr txBox="1"/>
            <p:nvPr/>
          </p:nvSpPr>
          <p:spPr>
            <a:xfrm rot="16200000">
              <a:off x="3453635" y="10473410"/>
              <a:ext cx="76495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GFB1I1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458A74F6-84B8-3847-9EFB-16200A2C8707}"/>
                </a:ext>
              </a:extLst>
            </p:cNvPr>
            <p:cNvSpPr txBox="1"/>
            <p:nvPr/>
          </p:nvSpPr>
          <p:spPr>
            <a:xfrm rot="16200000">
              <a:off x="4650228" y="10380501"/>
              <a:ext cx="5613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AG3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2753D05A-15C2-E544-BE3A-48C3D47B0F43}"/>
                </a:ext>
              </a:extLst>
            </p:cNvPr>
            <p:cNvSpPr txBox="1"/>
            <p:nvPr/>
          </p:nvSpPr>
          <p:spPr>
            <a:xfrm rot="16200000">
              <a:off x="4929644" y="10384078"/>
              <a:ext cx="5774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RG1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01A8B387-9163-BB46-8CA7-A956C22C8CF3}"/>
                </a:ext>
              </a:extLst>
            </p:cNvPr>
            <p:cNvSpPr txBox="1"/>
            <p:nvPr/>
          </p:nvSpPr>
          <p:spPr>
            <a:xfrm rot="16200000">
              <a:off x="5207338" y="10395215"/>
              <a:ext cx="5774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RG2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D14D1AA1-503F-4A45-A2C6-F1E26E7E0373}"/>
                </a:ext>
              </a:extLst>
            </p:cNvPr>
            <p:cNvSpPr txBox="1"/>
            <p:nvPr/>
          </p:nvSpPr>
          <p:spPr>
            <a:xfrm rot="16200000">
              <a:off x="5494345" y="10395214"/>
              <a:ext cx="5469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68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E00175CB-3BCE-EC48-A2DD-533ACD2D6A18}"/>
                </a:ext>
              </a:extLst>
            </p:cNvPr>
            <p:cNvSpPr txBox="1"/>
            <p:nvPr/>
          </p:nvSpPr>
          <p:spPr>
            <a:xfrm rot="16200000">
              <a:off x="5799662" y="10350554"/>
              <a:ext cx="4908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IF1</a:t>
              </a:r>
            </a:p>
          </p:txBody>
        </p:sp>
        <p:grpSp>
          <p:nvGrpSpPr>
            <p:cNvPr id="110" name="Group 109">
              <a:extLst>
                <a:ext uri="{FF2B5EF4-FFF2-40B4-BE49-F238E27FC236}">
                  <a16:creationId xmlns:a16="http://schemas.microsoft.com/office/drawing/2014/main" id="{1BCCEE20-08C1-134D-8D59-45DB08D91806}"/>
                </a:ext>
              </a:extLst>
            </p:cNvPr>
            <p:cNvGrpSpPr/>
            <p:nvPr/>
          </p:nvGrpSpPr>
          <p:grpSpPr>
            <a:xfrm>
              <a:off x="1524671" y="10623624"/>
              <a:ext cx="4722675" cy="826828"/>
              <a:chOff x="1524671" y="10623624"/>
              <a:chExt cx="4722675" cy="826828"/>
            </a:xfrm>
          </p:grpSpPr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2B4F28FA-4D8F-F54E-AA2E-9FCD671ADA18}"/>
                  </a:ext>
                </a:extLst>
              </p:cNvPr>
              <p:cNvSpPr txBox="1"/>
              <p:nvPr/>
            </p:nvSpPr>
            <p:spPr>
              <a:xfrm rot="16200000">
                <a:off x="1412460" y="10810311"/>
                <a:ext cx="5629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****</a:t>
                </a:r>
                <a:endPara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699ACBDC-29A2-1740-A402-234C5D7B7B1A}"/>
                  </a:ext>
                </a:extLst>
              </p:cNvPr>
              <p:cNvSpPr txBox="1"/>
              <p:nvPr/>
            </p:nvSpPr>
            <p:spPr>
              <a:xfrm rot="16200000">
                <a:off x="1666311" y="10992099"/>
                <a:ext cx="5629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****</a:t>
                </a:r>
                <a:endPara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7E71E33C-D78B-4A46-ABFD-5CB4D435170F}"/>
                  </a:ext>
                </a:extLst>
              </p:cNvPr>
              <p:cNvSpPr txBox="1"/>
              <p:nvPr/>
            </p:nvSpPr>
            <p:spPr>
              <a:xfrm rot="16200000">
                <a:off x="1959679" y="10999688"/>
                <a:ext cx="5629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****</a:t>
                </a:r>
                <a:endPara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4186F24E-7F3B-3C40-971B-2E54C6740F64}"/>
                  </a:ext>
                </a:extLst>
              </p:cNvPr>
              <p:cNvSpPr txBox="1"/>
              <p:nvPr/>
            </p:nvSpPr>
            <p:spPr>
              <a:xfrm rot="16200000">
                <a:off x="2258460" y="10767206"/>
                <a:ext cx="48282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***</a:t>
                </a:r>
                <a:endPara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AF38E067-5E5C-5F4D-AAAB-75CAE3D4793D}"/>
                  </a:ext>
                </a:extLst>
              </p:cNvPr>
              <p:cNvSpPr txBox="1"/>
              <p:nvPr/>
            </p:nvSpPr>
            <p:spPr>
              <a:xfrm rot="16200000">
                <a:off x="2507014" y="10799336"/>
                <a:ext cx="5629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****</a:t>
                </a:r>
                <a:endPara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E64C7B51-ADCC-D54F-837D-F0772D0159E5}"/>
                  </a:ext>
                </a:extLst>
              </p:cNvPr>
              <p:cNvSpPr txBox="1"/>
              <p:nvPr/>
            </p:nvSpPr>
            <p:spPr>
              <a:xfrm rot="16200000">
                <a:off x="3313758" y="10799335"/>
                <a:ext cx="5629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****</a:t>
                </a:r>
                <a:endPara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60EA12AA-7CC6-564D-ACCD-38B22339A6DD}"/>
                  </a:ext>
                </a:extLst>
              </p:cNvPr>
              <p:cNvSpPr txBox="1"/>
              <p:nvPr/>
            </p:nvSpPr>
            <p:spPr>
              <a:xfrm rot="16200000">
                <a:off x="4730795" y="10725616"/>
                <a:ext cx="48282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***</a:t>
                </a:r>
                <a:endPara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C2DB95D6-2D58-F045-ADD5-271AAAE47D7A}"/>
                  </a:ext>
                </a:extLst>
              </p:cNvPr>
              <p:cNvSpPr txBox="1"/>
              <p:nvPr/>
            </p:nvSpPr>
            <p:spPr>
              <a:xfrm rot="16200000">
                <a:off x="5515487" y="10735835"/>
                <a:ext cx="5629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****</a:t>
                </a:r>
                <a:endPara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01B45270-D5E7-7E4F-9B2E-E3464E40A747}"/>
                  </a:ext>
                </a:extLst>
              </p:cNvPr>
              <p:cNvSpPr txBox="1"/>
              <p:nvPr/>
            </p:nvSpPr>
            <p:spPr>
              <a:xfrm rot="16200000">
                <a:off x="5796581" y="10738019"/>
                <a:ext cx="5629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****</a:t>
                </a:r>
                <a:endPara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239BDE27-C17C-E74C-896E-F1A77D9F5B2D}"/>
                </a:ext>
              </a:extLst>
            </p:cNvPr>
            <p:cNvSpPr txBox="1"/>
            <p:nvPr/>
          </p:nvSpPr>
          <p:spPr>
            <a:xfrm rot="16200000">
              <a:off x="3991016" y="11071713"/>
              <a:ext cx="32252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*</a:t>
              </a:r>
              <a:endParaRPr lang="en-US" sz="1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Oval 154">
              <a:extLst>
                <a:ext uri="{FF2B5EF4-FFF2-40B4-BE49-F238E27FC236}">
                  <a16:creationId xmlns:a16="http://schemas.microsoft.com/office/drawing/2014/main" id="{3C1CC191-4A82-1A46-9968-2E31C63487DE}"/>
                </a:ext>
              </a:extLst>
            </p:cNvPr>
            <p:cNvSpPr/>
            <p:nvPr/>
          </p:nvSpPr>
          <p:spPr>
            <a:xfrm>
              <a:off x="4036937" y="4005303"/>
              <a:ext cx="230682" cy="240632"/>
            </a:xfrm>
            <a:prstGeom prst="ellipse">
              <a:avLst/>
            </a:prstGeom>
            <a:solidFill>
              <a:srgbClr val="538FF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7" name="Oval 156">
              <a:extLst>
                <a:ext uri="{FF2B5EF4-FFF2-40B4-BE49-F238E27FC236}">
                  <a16:creationId xmlns:a16="http://schemas.microsoft.com/office/drawing/2014/main" id="{F3028686-72F8-7142-8264-DB891A6B7C88}"/>
                </a:ext>
              </a:extLst>
            </p:cNvPr>
            <p:cNvSpPr/>
            <p:nvPr/>
          </p:nvSpPr>
          <p:spPr>
            <a:xfrm>
              <a:off x="4037397" y="5041653"/>
              <a:ext cx="230682" cy="240632"/>
            </a:xfrm>
            <a:prstGeom prst="ellipse">
              <a:avLst/>
            </a:prstGeom>
            <a:solidFill>
              <a:srgbClr val="00EE6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44221BAA-ECFD-0D4E-B096-636718DE12EA}"/>
              </a:ext>
            </a:extLst>
          </p:cNvPr>
          <p:cNvSpPr txBox="1"/>
          <p:nvPr/>
        </p:nvSpPr>
        <p:spPr>
          <a:xfrm>
            <a:off x="79125" y="5093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24AD3178-5810-D34A-8C8E-0310D863BA28}"/>
              </a:ext>
            </a:extLst>
          </p:cNvPr>
          <p:cNvGrpSpPr/>
          <p:nvPr/>
        </p:nvGrpSpPr>
        <p:grpSpPr>
          <a:xfrm>
            <a:off x="1033427" y="442019"/>
            <a:ext cx="2921855" cy="2905216"/>
            <a:chOff x="250129" y="264503"/>
            <a:chExt cx="2921855" cy="2905216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381A286-DD5D-9346-BADB-B489B4A2E3A7}"/>
                </a:ext>
              </a:extLst>
            </p:cNvPr>
            <p:cNvSpPr txBox="1"/>
            <p:nvPr/>
          </p:nvSpPr>
          <p:spPr>
            <a:xfrm rot="16200000">
              <a:off x="-160171" y="1534442"/>
              <a:ext cx="13003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Expression GZMA 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235BB3D-5C23-6044-B9AB-7642FEEC7EEC}"/>
                </a:ext>
              </a:extLst>
            </p:cNvPr>
            <p:cNvSpPr txBox="1"/>
            <p:nvPr/>
          </p:nvSpPr>
          <p:spPr>
            <a:xfrm>
              <a:off x="250129" y="356228"/>
              <a:ext cx="1847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BB702D58-1101-504D-BAF7-E1EDD5FB62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917" r="12707" b="2235"/>
            <a:stretch/>
          </p:blipFill>
          <p:spPr>
            <a:xfrm>
              <a:off x="960120" y="320140"/>
              <a:ext cx="1827286" cy="2760061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CF134BD-D9E8-C743-94DD-E5D25E08C04E}"/>
                </a:ext>
              </a:extLst>
            </p:cNvPr>
            <p:cNvSpPr txBox="1"/>
            <p:nvPr/>
          </p:nvSpPr>
          <p:spPr>
            <a:xfrm>
              <a:off x="2590229" y="1141328"/>
              <a:ext cx="564578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rgbClr val="0090F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ZMA</a:t>
              </a:r>
            </a:p>
            <a:p>
              <a:pPr algn="ctr"/>
              <a:r>
                <a:rPr lang="en-GB" sz="1000" b="1" dirty="0">
                  <a:solidFill>
                    <a:srgbClr val="0090F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  <a:p>
              <a:pPr algn="ctr"/>
              <a:r>
                <a:rPr lang="en-GB" sz="1000" b="1" dirty="0">
                  <a:solidFill>
                    <a:srgbClr val="0090F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07</a:t>
              </a:r>
              <a:endParaRPr lang="en-US" sz="1000" b="1" dirty="0">
                <a:solidFill>
                  <a:srgbClr val="0090F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C7D0ABA-01F9-084E-9425-8866DD6DFABA}"/>
                </a:ext>
              </a:extLst>
            </p:cNvPr>
            <p:cNvSpPr txBox="1"/>
            <p:nvPr/>
          </p:nvSpPr>
          <p:spPr>
            <a:xfrm>
              <a:off x="2607406" y="2198202"/>
              <a:ext cx="564578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rgbClr val="00EE6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ZMA</a:t>
              </a:r>
            </a:p>
            <a:p>
              <a:pPr algn="ctr"/>
              <a:r>
                <a:rPr lang="en-GB" sz="1000" b="1" dirty="0">
                  <a:solidFill>
                    <a:srgbClr val="00EE6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</a:p>
            <a:p>
              <a:pPr algn="ctr"/>
              <a:r>
                <a:rPr lang="en-GB" sz="1000" b="1" dirty="0">
                  <a:solidFill>
                    <a:srgbClr val="00EE6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07</a:t>
              </a:r>
              <a:endParaRPr lang="en-US" sz="1000" b="1" dirty="0">
                <a:solidFill>
                  <a:srgbClr val="00EE6D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877DD75-AF7C-8040-8E5A-8E76CF1B69A2}"/>
                </a:ext>
              </a:extLst>
            </p:cNvPr>
            <p:cNvSpPr txBox="1"/>
            <p:nvPr/>
          </p:nvSpPr>
          <p:spPr>
            <a:xfrm>
              <a:off x="683885" y="2923498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21BCAFA-BD5E-C845-A10D-BE9DB37C312E}"/>
                </a:ext>
              </a:extLst>
            </p:cNvPr>
            <p:cNvSpPr txBox="1"/>
            <p:nvPr/>
          </p:nvSpPr>
          <p:spPr>
            <a:xfrm>
              <a:off x="690416" y="2383119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6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8076CA7-4C30-CD40-A921-0AF765F12AB5}"/>
                </a:ext>
              </a:extLst>
            </p:cNvPr>
            <p:cNvSpPr txBox="1"/>
            <p:nvPr/>
          </p:nvSpPr>
          <p:spPr>
            <a:xfrm>
              <a:off x="623871" y="1861055"/>
              <a:ext cx="3962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28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548CC34-293B-844B-A770-AFC005D7E25B}"/>
                </a:ext>
              </a:extLst>
            </p:cNvPr>
            <p:cNvSpPr txBox="1"/>
            <p:nvPr/>
          </p:nvSpPr>
          <p:spPr>
            <a:xfrm>
              <a:off x="623871" y="1328820"/>
              <a:ext cx="3962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56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DE58927-3A31-704C-A36D-03E4A03C5F68}"/>
                </a:ext>
              </a:extLst>
            </p:cNvPr>
            <p:cNvSpPr txBox="1"/>
            <p:nvPr/>
          </p:nvSpPr>
          <p:spPr>
            <a:xfrm>
              <a:off x="623871" y="796585"/>
              <a:ext cx="3962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1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AAF43F0-0B9F-0A42-933F-1DF279066FAD}"/>
                </a:ext>
              </a:extLst>
            </p:cNvPr>
            <p:cNvSpPr txBox="1"/>
            <p:nvPr/>
          </p:nvSpPr>
          <p:spPr>
            <a:xfrm>
              <a:off x="575542" y="264503"/>
              <a:ext cx="4667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02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Right Brace 3">
              <a:extLst>
                <a:ext uri="{FF2B5EF4-FFF2-40B4-BE49-F238E27FC236}">
                  <a16:creationId xmlns:a16="http://schemas.microsoft.com/office/drawing/2014/main" id="{792D77AC-4561-074B-AC08-04131B98D5DE}"/>
                </a:ext>
              </a:extLst>
            </p:cNvPr>
            <p:cNvSpPr/>
            <p:nvPr/>
          </p:nvSpPr>
          <p:spPr>
            <a:xfrm>
              <a:off x="2484346" y="607423"/>
              <a:ext cx="178315" cy="1650783"/>
            </a:xfrm>
            <a:prstGeom prst="rightBrace">
              <a:avLst/>
            </a:prstGeom>
            <a:ln w="12700">
              <a:solidFill>
                <a:srgbClr val="538FF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Right Brace 21">
              <a:extLst>
                <a:ext uri="{FF2B5EF4-FFF2-40B4-BE49-F238E27FC236}">
                  <a16:creationId xmlns:a16="http://schemas.microsoft.com/office/drawing/2014/main" id="{105A2648-4142-AF42-9523-D163F1BAA157}"/>
                </a:ext>
              </a:extLst>
            </p:cNvPr>
            <p:cNvSpPr/>
            <p:nvPr/>
          </p:nvSpPr>
          <p:spPr>
            <a:xfrm>
              <a:off x="2484346" y="2284617"/>
              <a:ext cx="178315" cy="344723"/>
            </a:xfrm>
            <a:prstGeom prst="rightBrace">
              <a:avLst/>
            </a:prstGeom>
            <a:ln w="12700">
              <a:solidFill>
                <a:srgbClr val="00EE6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00EE6D"/>
                </a:solidFill>
              </a:endParaRP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C0D307E3-2EB1-F94B-B218-8E386EA2E47B}"/>
              </a:ext>
            </a:extLst>
          </p:cNvPr>
          <p:cNvSpPr txBox="1"/>
          <p:nvPr/>
        </p:nvSpPr>
        <p:spPr>
          <a:xfrm>
            <a:off x="-21619" y="8946562"/>
            <a:ext cx="704026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croarray data from 214 GBM patients in the REMBRANDT study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214 patients were classified as either high GZMA expressers (n=107) or low GZMA expressers 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n=107) by splitting at the median expression value (inset graph). The main graph shows expression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selected genes in the GZMA high (blue) and GZMA low (green) patient groups.  Dots represent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dividual patients, with the mean value indicated by a bar. Each pair of samples was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using 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Mann Whitney U test. Samples showing statistically different distributions are indicated under the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x-axis; *P&lt;0.05, ***P=0.0001, ****P&lt;0.0001. The REMBRANDT gene expression data was 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wnloaded fro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etastasis.co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3982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</TotalTime>
  <Words>195</Words>
  <Application>Microsoft Macintosh PowerPoint</Application>
  <PresentationFormat>Widescreen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aham Cook</dc:creator>
  <cp:lastModifiedBy>Erica Watson</cp:lastModifiedBy>
  <cp:revision>15</cp:revision>
  <cp:lastPrinted>2019-07-01T16:07:22Z</cp:lastPrinted>
  <dcterms:created xsi:type="dcterms:W3CDTF">2018-07-17T14:33:11Z</dcterms:created>
  <dcterms:modified xsi:type="dcterms:W3CDTF">2019-07-01T16:07:32Z</dcterms:modified>
</cp:coreProperties>
</file>